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6EC6AB8-4508-143B-2CCC-16B62E8F7D2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CDD288FA-0DF5-A83D-6D8E-5AF717F55C5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B9E206D-4A79-1785-B72D-7BC571F9BB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C3468-1A3D-DC4A-AC0E-ECC8568C6465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A316E8C-77BA-B3B7-FECB-151C29605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60D9D22-15BD-3240-7FDA-924083E965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48E13-DE64-2C4E-83DE-6E279564073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36954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1173874-214C-562B-D4C2-57BD18AB1B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75823DFB-EE6D-676E-B4D0-0833F81314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B899A8B-537B-35EC-C7BD-D46ED385F1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C3468-1A3D-DC4A-AC0E-ECC8568C6465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16F46B0-54AF-6D75-59CD-AF7BE15E91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9E5F5C9-1CB8-4C28-F3E4-BABC451D32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48E13-DE64-2C4E-83DE-6E279564073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43623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459C6814-ABDE-4871-51B9-50A336F9AD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B73B2C15-6A87-1311-8B95-6B5E82DEC4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6EFC436-4209-7721-0BCF-6720F955F0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C3468-1A3D-DC4A-AC0E-ECC8568C6465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51913E7-78AA-E36C-BEC2-7E3D018A71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8095D7C-35E6-C11A-F0FB-3A46ACF577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48E13-DE64-2C4E-83DE-6E279564073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8054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1D782F2-655B-48E0-D444-7F6D49635A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CFB24F6-C410-78D4-62BC-54C09AC8F36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A93C510-D52C-7AF1-ECA6-E61909E065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C3468-1A3D-DC4A-AC0E-ECC8568C6465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52FE45A-6E09-CA9D-5AC4-B43A16590D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7633345-DB90-90EB-EE5D-E084DA07C6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48E13-DE64-2C4E-83DE-6E279564073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65305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589DB8E-DB0A-19B7-2351-1610C328F3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02A6907-90F1-150A-F1A7-CD7BB74CCC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D85DA4A-6684-FA9F-4CE2-AC1A2D20BB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C3468-1A3D-DC4A-AC0E-ECC8568C6465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C8AA71A-D317-0163-1991-E38DB49A71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E21BA17-5F0F-AD5F-F0DF-68E271174D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48E13-DE64-2C4E-83DE-6E279564073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619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2D29457-DAF4-83B1-A4BB-43CB65A2DD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B6E0CAF-7879-FB5C-784D-AD8713C0C07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D32F1624-00F6-DEF6-B4C2-A337E9E6FE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6B99F9D-8373-A77C-C137-F727647778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C3468-1A3D-DC4A-AC0E-ECC8568C6465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4EB068F-EB02-9C29-A241-B9EACE18A2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0FC1B27-DB53-DA08-423A-ED291987DF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48E13-DE64-2C4E-83DE-6E279564073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68446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E9960EC-1FA3-E2E5-7FD7-15B4A7289A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A97ADD3-ED8A-6C33-5FCE-8E06B45092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FF278A91-370A-0155-6AD1-CAF81C2B8A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4C05DA56-D224-431D-05E8-D9F9F77511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E73311F5-E619-5311-C528-6543E9B71D5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71CD1E43-468A-43B8-9569-FA350D41BD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C3468-1A3D-DC4A-AC0E-ECC8568C6465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84E4FA31-EF33-7B6F-7285-C424A080C7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8B71AB52-4D14-1501-1A88-3DB9AE44C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48E13-DE64-2C4E-83DE-6E279564073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70956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D6F30DE-ABD8-E50B-44D0-D620ACDDEE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C1574DC5-9E75-B842-D2A2-F65372AE0F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C3468-1A3D-DC4A-AC0E-ECC8568C6465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15CDF71B-93F7-E93D-DA6C-0DDA00A609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3ED5FB78-F5BF-083F-5725-9BDBB09592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48E13-DE64-2C4E-83DE-6E279564073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0401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B52B12D2-A2BE-DC33-18E8-A91DAE30F9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C3468-1A3D-DC4A-AC0E-ECC8568C6465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AAC0E22E-366C-B5E2-9919-D5B25D2615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466D576B-44E0-2810-3107-D7C4965D9D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48E13-DE64-2C4E-83DE-6E279564073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1422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0B705B9-6519-70AC-1D7C-4D72B5E685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2138715-54AD-97A4-24F6-AEE67768A0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746ADDD6-89B7-43CB-C721-06899466D5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52AF7E7-A78D-7590-312D-2D0B8D38A5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C3468-1A3D-DC4A-AC0E-ECC8568C6465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4DE79AB1-4B03-0E16-7186-857268BFDD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0EE1C0F-6587-0BDF-6BEB-CB4F6F50DC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48E13-DE64-2C4E-83DE-6E279564073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93098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696BCE6-A570-0322-D714-A880A001D2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F9793C9F-B696-1A2F-90AB-C207BBBB140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A906A879-B17D-03D7-C65C-C696A4DC4A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F558384-1511-BAD1-DDF4-700D6DE283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C3468-1A3D-DC4A-AC0E-ECC8568C6465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7FB3F90-FEA7-C09C-5987-71B4F08909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FCF71310-C236-A733-6226-F3A0E2F67F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48E13-DE64-2C4E-83DE-6E279564073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41527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2C1B6D3C-1B47-CAF8-B078-DB21310437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83674F7-D4FB-91DD-BCDB-29A0B02CCD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79CE3A6-A4EF-9C16-1AA5-32DD1FAF25A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FC3468-1A3D-DC4A-AC0E-ECC8568C6465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4BDB4CF-22E2-9D83-C522-BBC11FD648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92FF624-CF41-9B3D-9FD7-BBB54B61C5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048E13-DE64-2C4E-83DE-6E279564073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93264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62D1116A-8198-A5C4-B573-A1C02E5BC5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95077" y="1611803"/>
            <a:ext cx="5166053" cy="4129001"/>
          </a:xfrm>
          <a:prstGeom prst="rect">
            <a:avLst/>
          </a:prstGeom>
        </p:spPr>
      </p:pic>
      <p:cxnSp>
        <p:nvCxnSpPr>
          <p:cNvPr id="8" name="Conector recto de flecha 7">
            <a:extLst>
              <a:ext uri="{FF2B5EF4-FFF2-40B4-BE49-F238E27FC236}">
                <a16:creationId xmlns:a16="http://schemas.microsoft.com/office/drawing/2014/main" id="{4AB74FA9-B69C-0F7A-EF11-A26F63C01118}"/>
              </a:ext>
            </a:extLst>
          </p:cNvPr>
          <p:cNvCxnSpPr>
            <a:cxnSpLocks/>
          </p:cNvCxnSpPr>
          <p:nvPr/>
        </p:nvCxnSpPr>
        <p:spPr>
          <a:xfrm rot="5400000" flipH="1">
            <a:off x="8513271" y="3089806"/>
            <a:ext cx="0" cy="338972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CuadroTexto 8">
            <a:extLst>
              <a:ext uri="{FF2B5EF4-FFF2-40B4-BE49-F238E27FC236}">
                <a16:creationId xmlns:a16="http://schemas.microsoft.com/office/drawing/2014/main" id="{96C84C5A-B064-6B0C-D864-7CC22DA42695}"/>
              </a:ext>
            </a:extLst>
          </p:cNvPr>
          <p:cNvSpPr txBox="1"/>
          <p:nvPr/>
        </p:nvSpPr>
        <p:spPr>
          <a:xfrm>
            <a:off x="8790626" y="3014827"/>
            <a:ext cx="6399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/>
              <a:t>SPS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17A82703-E010-DC92-065E-4DD83A646258}"/>
              </a:ext>
            </a:extLst>
          </p:cNvPr>
          <p:cNvSpPr txBox="1"/>
          <p:nvPr/>
        </p:nvSpPr>
        <p:spPr>
          <a:xfrm>
            <a:off x="5620775" y="1617444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/>
              <a:t>0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B455EE44-E62A-9DB4-9571-08356AA30940}"/>
              </a:ext>
            </a:extLst>
          </p:cNvPr>
          <p:cNvSpPr txBox="1"/>
          <p:nvPr/>
        </p:nvSpPr>
        <p:spPr>
          <a:xfrm>
            <a:off x="5953711" y="1617444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/>
              <a:t>48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CC4A8479-F9AE-DAB4-608E-6989C153B90F}"/>
              </a:ext>
            </a:extLst>
          </p:cNvPr>
          <p:cNvSpPr txBox="1"/>
          <p:nvPr/>
        </p:nvSpPr>
        <p:spPr>
          <a:xfrm>
            <a:off x="6690236" y="1617444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/>
              <a:t>48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0037D436-5D8F-04D0-0547-413F7F97EAA7}"/>
              </a:ext>
            </a:extLst>
          </p:cNvPr>
          <p:cNvSpPr txBox="1"/>
          <p:nvPr/>
        </p:nvSpPr>
        <p:spPr>
          <a:xfrm>
            <a:off x="6368050" y="1617444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/>
              <a:t>0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1DA71A0B-2D5C-3598-E37F-903DF6262164}"/>
              </a:ext>
            </a:extLst>
          </p:cNvPr>
          <p:cNvSpPr txBox="1"/>
          <p:nvPr/>
        </p:nvSpPr>
        <p:spPr>
          <a:xfrm>
            <a:off x="7494383" y="1438769"/>
            <a:ext cx="274487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Hours after  IPTG (1mM) and AsO</a:t>
            </a:r>
            <a:r>
              <a:rPr lang="en-GB" sz="1600" b="1" baseline="-25000" dirty="0"/>
              <a:t>2</a:t>
            </a:r>
            <a:r>
              <a:rPr lang="en-GB" sz="1600" b="1" baseline="30000" dirty="0"/>
              <a:t>- </a:t>
            </a:r>
            <a:r>
              <a:rPr lang="en-GB" sz="1600" b="1" dirty="0"/>
              <a:t>(50 </a:t>
            </a:r>
            <a:r>
              <a:rPr lang="en-GB" sz="1600" b="1" dirty="0">
                <a:latin typeface="Symbol" pitchFamily="2" charset="2"/>
              </a:rPr>
              <a:t>m</a:t>
            </a:r>
            <a:r>
              <a:rPr lang="en-GB" sz="1600" b="1" dirty="0"/>
              <a:t>M) addition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9879CF09-AC6D-D2E3-08C2-8604B023F445}"/>
              </a:ext>
            </a:extLst>
          </p:cNvPr>
          <p:cNvSpPr txBox="1"/>
          <p:nvPr/>
        </p:nvSpPr>
        <p:spPr>
          <a:xfrm>
            <a:off x="9507129" y="3080940"/>
            <a:ext cx="1136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81.44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8D8DB333-8BCB-FC88-A2E6-42A33045D059}"/>
              </a:ext>
            </a:extLst>
          </p:cNvPr>
          <p:cNvSpPr txBox="1"/>
          <p:nvPr/>
        </p:nvSpPr>
        <p:spPr>
          <a:xfrm>
            <a:off x="4805640" y="1291625"/>
            <a:ext cx="9701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M (</a:t>
            </a:r>
            <a:r>
              <a:rPr lang="en-GB" b="1" dirty="0" err="1"/>
              <a:t>KDa</a:t>
            </a:r>
            <a:r>
              <a:rPr lang="en-GB" b="1" dirty="0"/>
              <a:t>)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AD941E3D-5976-B9FD-5E2C-68B1E4F4F004}"/>
              </a:ext>
            </a:extLst>
          </p:cNvPr>
          <p:cNvSpPr txBox="1"/>
          <p:nvPr/>
        </p:nvSpPr>
        <p:spPr>
          <a:xfrm>
            <a:off x="367861" y="288117"/>
            <a:ext cx="79759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Original </a:t>
            </a:r>
            <a:r>
              <a:rPr lang="es-ES" dirty="0" err="1"/>
              <a:t>uncropped</a:t>
            </a:r>
            <a:r>
              <a:rPr lang="es-ES" dirty="0"/>
              <a:t> Gel </a:t>
            </a:r>
            <a:r>
              <a:rPr lang="es-ES" dirty="0" err="1"/>
              <a:t>of</a:t>
            </a:r>
            <a:r>
              <a:rPr lang="es-ES" dirty="0"/>
              <a:t> Figure S3.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right</a:t>
            </a:r>
            <a:r>
              <a:rPr lang="es-ES" dirty="0"/>
              <a:t> </a:t>
            </a:r>
            <a:r>
              <a:rPr lang="es-ES" dirty="0" err="1"/>
              <a:t>part</a:t>
            </a:r>
            <a:r>
              <a:rPr lang="es-ES" dirty="0"/>
              <a:t> after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markers</a:t>
            </a:r>
            <a:r>
              <a:rPr lang="es-ES" dirty="0"/>
              <a:t> </a:t>
            </a:r>
            <a:r>
              <a:rPr lang="es-ES" dirty="0" err="1"/>
              <a:t>corresponds</a:t>
            </a:r>
            <a:r>
              <a:rPr lang="es-ES" dirty="0"/>
              <a:t> </a:t>
            </a:r>
            <a:r>
              <a:rPr lang="es-ES" dirty="0" err="1"/>
              <a:t>to</a:t>
            </a:r>
            <a:r>
              <a:rPr lang="es-ES" dirty="0"/>
              <a:t>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samples</a:t>
            </a:r>
            <a:r>
              <a:rPr lang="es-ES" dirty="0"/>
              <a:t> </a:t>
            </a:r>
            <a:r>
              <a:rPr lang="es-ES" dirty="0" err="1"/>
              <a:t>shown</a:t>
            </a:r>
            <a:r>
              <a:rPr lang="es-ES" dirty="0"/>
              <a:t> in Figure S3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6802797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45</Words>
  <Application>Microsoft Macintosh PowerPoint</Application>
  <PresentationFormat>Panorámica</PresentationFormat>
  <Paragraphs>9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crosoft Office User</dc:creator>
  <cp:lastModifiedBy>Microsoft Office User</cp:lastModifiedBy>
  <cp:revision>4</cp:revision>
  <dcterms:created xsi:type="dcterms:W3CDTF">2025-09-09T08:17:52Z</dcterms:created>
  <dcterms:modified xsi:type="dcterms:W3CDTF">2025-09-09T09:00:17Z</dcterms:modified>
</cp:coreProperties>
</file>